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040313" cy="46799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DA44E-8D73-4C18-A959-16C3E3FE1E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453564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2000" y="2705040"/>
            <a:ext cx="453564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13A6A8-1BF8-487C-93AB-C0F31EBBAC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76160" y="109188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2000" y="270504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76160" y="270504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38ED2-4BFB-4D7D-9B8F-13E686ED2D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146016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85600" y="1091880"/>
            <a:ext cx="146016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19200" y="1091880"/>
            <a:ext cx="146016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2000" y="2705040"/>
            <a:ext cx="146016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85600" y="2705040"/>
            <a:ext cx="146016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19200" y="2705040"/>
            <a:ext cx="146016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0A5F4-1C8E-4436-8DE2-04E1429492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2000" y="1091880"/>
            <a:ext cx="4535640" cy="308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76"/>
              </a:spcBef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2E7B7-B004-434C-8E68-D24DE1A93A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4535640" cy="30877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D1DB1-42E7-4108-860E-719B24621D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2213280" cy="30877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76160" y="1091880"/>
            <a:ext cx="2213280" cy="30877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A04E3-0C8B-40D2-B328-AC83847352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5122F0-678A-4E8C-8703-57C83ED95F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2000" y="187200"/>
            <a:ext cx="4535640" cy="361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76"/>
              </a:spcBef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AE3A3E-0E01-4CDD-9076-1EBE5A8540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76160" y="1091880"/>
            <a:ext cx="2213280" cy="30877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2000" y="270504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DA19A-0F83-40DC-804B-BD772C93B8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2213280" cy="30877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76160" y="109188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76160" y="270504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791C9-1E1E-4180-AC58-57D5905AB7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2000" y="109188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76160" y="1091880"/>
            <a:ext cx="221328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2000" y="2705040"/>
            <a:ext cx="4535640" cy="1472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AB631-F361-43DC-83EA-48993605CE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2000" y="187200"/>
            <a:ext cx="4535640" cy="7797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2000" y="1091880"/>
            <a:ext cx="4535640" cy="30877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marL="208080" indent="-20808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1" marL="450720" indent="-17280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2" marL="693720" indent="-13824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971640" indent="-13824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4" marL="1249200" indent="-13788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5" marL="1249200" indent="-13788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6" marL="1249200" indent="-13788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2360" y="4262400"/>
            <a:ext cx="1176480" cy="3240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Autofit/>
          </a:bodyPr>
          <a:lstStyle>
            <a:lvl1pPr indent="0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22240" y="4262400"/>
            <a:ext cx="1595160" cy="3240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Autofit/>
          </a:bodyPr>
          <a:lstStyle>
            <a:lvl1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611520" y="4262400"/>
            <a:ext cx="1176480" cy="3240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Autofit/>
          </a:bodyPr>
          <a:lstStyle>
            <a:lvl1pPr indent="0" algn="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55480"/>
                <a:tab algn="l" pos="1111320"/>
                <a:tab algn="l" pos="1666800"/>
                <a:tab algn="l" pos="2222640"/>
                <a:tab algn="l" pos="2778120"/>
                <a:tab algn="l" pos="3333600"/>
                <a:tab algn="l" pos="3889440"/>
                <a:tab algn="l" pos="4444920"/>
                <a:tab algn="l" pos="5000760"/>
                <a:tab algn="l" pos="5556240"/>
                <a:tab algn="l" pos="6111720"/>
                <a:tab algn="l" pos="6667560"/>
                <a:tab algn="l" pos="7223040"/>
                <a:tab algn="l" pos="7778880"/>
                <a:tab algn="l" pos="8334360"/>
                <a:tab algn="l" pos="8889840"/>
                <a:tab algn="l" pos="9445680"/>
                <a:tab algn="l" pos="10001160"/>
                <a:tab algn="l" pos="10557000"/>
              </a:tabLst>
            </a:pPr>
            <a:fld id="{69603D39-6EB2-4D4C-B3D2-F5E72BE328EE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908800" y="4005360"/>
            <a:ext cx="1187640" cy="632520"/>
            <a:chOff x="2908800" y="4005360"/>
            <a:chExt cx="1187640" cy="632520"/>
          </a:xfrm>
        </p:grpSpPr>
        <p:sp>
          <p:nvSpPr>
            <p:cNvPr id="42" name=""/>
            <p:cNvSpPr/>
            <p:nvPr/>
          </p:nvSpPr>
          <p:spPr>
            <a:xfrm>
              <a:off x="2908800" y="4005360"/>
              <a:ext cx="75492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Os02g072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2970000" y="4213440"/>
              <a:ext cx="1126440" cy="424440"/>
              <a:chOff x="2970000" y="4213440"/>
              <a:chExt cx="1126440" cy="424440"/>
            </a:xfrm>
          </p:grpSpPr>
          <p:sp>
            <p:nvSpPr>
              <p:cNvPr id="44" name=""/>
              <p:cNvSpPr/>
              <p:nvPr/>
            </p:nvSpPr>
            <p:spPr>
              <a:xfrm>
                <a:off x="2970000" y="4213440"/>
                <a:ext cx="1126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87"/>
                  </a:spcBef>
                  <a:tabLst>
                    <a:tab algn="l" pos="0"/>
                    <a:tab algn="l" pos="860400"/>
                    <a:tab algn="l" pos="1720800"/>
                    <a:tab algn="l" pos="2583000"/>
                    <a:tab algn="l" pos="3443400"/>
                    <a:tab algn="l" pos="4303800"/>
                    <a:tab algn="l" pos="5164200"/>
                    <a:tab algn="l" pos="6024600"/>
                    <a:tab algn="l" pos="6886440"/>
                    <a:tab algn="l" pos="7746840"/>
                    <a:tab algn="l" pos="8607600"/>
                    <a:tab algn="l" pos="9468000"/>
                    <a:tab algn="l" pos="9894960"/>
                    <a:tab algn="l" pos="10325160"/>
                    <a:tab algn="l" pos="1075536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orphobilinoge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3012840" y="4307760"/>
                <a:ext cx="754920" cy="330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6040" rIns="86040" tIns="43200" bIns="43200" anchor="t">
                <a:spAutoFit/>
              </a:bodyPr>
              <a:p>
                <a:pPr algn="ctr">
                  <a:tabLst>
                    <a:tab algn="l" pos="0"/>
                    <a:tab algn="l" pos="860400"/>
                    <a:tab algn="l" pos="1720800"/>
                    <a:tab algn="l" pos="2581200"/>
                    <a:tab algn="l" pos="3441600"/>
                    <a:tab algn="l" pos="4302000"/>
                    <a:tab algn="l" pos="5162400"/>
                    <a:tab algn="l" pos="6022800"/>
                    <a:tab algn="l" pos="6883560"/>
                    <a:tab algn="l" pos="7743960"/>
                    <a:tab algn="l" pos="8604360"/>
                    <a:tab algn="l" pos="9464760"/>
                    <a:tab algn="l" pos="1032516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deamina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860400"/>
                    <a:tab algn="l" pos="1720800"/>
                    <a:tab algn="l" pos="2581200"/>
                    <a:tab algn="l" pos="3441600"/>
                    <a:tab algn="l" pos="4302000"/>
                    <a:tab algn="l" pos="5162400"/>
                    <a:tab algn="l" pos="6022800"/>
                    <a:tab algn="l" pos="6883560"/>
                    <a:tab algn="l" pos="7743960"/>
                    <a:tab algn="l" pos="8604360"/>
                    <a:tab algn="l" pos="9464760"/>
                    <a:tab algn="l" pos="1032516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(SbRPG748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46" name=""/>
          <p:cNvGrpSpPr/>
          <p:nvPr/>
        </p:nvGrpSpPr>
        <p:grpSpPr>
          <a:xfrm>
            <a:off x="3666960" y="4005360"/>
            <a:ext cx="2167920" cy="620640"/>
            <a:chOff x="3666960" y="4005360"/>
            <a:chExt cx="2167920" cy="620640"/>
          </a:xfrm>
        </p:grpSpPr>
        <p:sp>
          <p:nvSpPr>
            <p:cNvPr id="47" name=""/>
            <p:cNvSpPr/>
            <p:nvPr/>
          </p:nvSpPr>
          <p:spPr>
            <a:xfrm>
              <a:off x="3666960" y="4005360"/>
              <a:ext cx="754920" cy="330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spcBef>
                  <a:spcPts val="825"/>
                </a:spcBef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Os02g072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8" name=""/>
            <p:cNvGrpSpPr/>
            <p:nvPr/>
          </p:nvGrpSpPr>
          <p:grpSpPr>
            <a:xfrm>
              <a:off x="3794040" y="4224960"/>
              <a:ext cx="2040840" cy="401040"/>
              <a:chOff x="3794040" y="4224960"/>
              <a:chExt cx="2040840" cy="401040"/>
            </a:xfrm>
          </p:grpSpPr>
          <p:sp>
            <p:nvSpPr>
              <p:cNvPr id="49" name=""/>
              <p:cNvSpPr/>
              <p:nvPr/>
            </p:nvSpPr>
            <p:spPr>
              <a:xfrm>
                <a:off x="3794040" y="4224960"/>
                <a:ext cx="2040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spcBef>
                    <a:spcPts val="587"/>
                  </a:spcBef>
                  <a:tabLst>
                    <a:tab algn="l" pos="0"/>
                    <a:tab algn="l" pos="860400"/>
                    <a:tab algn="l" pos="1720800"/>
                    <a:tab algn="l" pos="2583000"/>
                    <a:tab algn="l" pos="3443400"/>
                    <a:tab algn="l" pos="4303800"/>
                    <a:tab algn="l" pos="5164200"/>
                    <a:tab algn="l" pos="6024600"/>
                    <a:tab algn="l" pos="6886440"/>
                    <a:tab algn="l" pos="7746840"/>
                    <a:tab algn="l" pos="8607600"/>
                    <a:tab algn="l" pos="9468000"/>
                    <a:tab algn="l" pos="9894960"/>
                    <a:tab algn="l" pos="10325160"/>
                    <a:tab algn="l" pos="1075536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ypothetica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832920" y="4295880"/>
                <a:ext cx="483840" cy="330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6040" rIns="86040" tIns="43200" bIns="43200" anchor="t">
                <a:spAutoFit/>
              </a:bodyPr>
              <a:p>
                <a:pPr>
                  <a:spcBef>
                    <a:spcPts val="587"/>
                  </a:spcBef>
                  <a:tabLst>
                    <a:tab algn="l" pos="0"/>
                    <a:tab algn="l" pos="860400"/>
                    <a:tab algn="l" pos="1720800"/>
                    <a:tab algn="l" pos="2581200"/>
                    <a:tab algn="l" pos="3441600"/>
                    <a:tab algn="l" pos="4302000"/>
                    <a:tab algn="l" pos="5162400"/>
                    <a:tab algn="l" pos="6022800"/>
                    <a:tab algn="l" pos="6883560"/>
                    <a:tab algn="l" pos="7743960"/>
                    <a:tab algn="l" pos="8604360"/>
                    <a:tab algn="l" pos="9464760"/>
                    <a:tab algn="l" pos="1032516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prote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860400"/>
                    <a:tab algn="l" pos="1720800"/>
                    <a:tab algn="l" pos="2581200"/>
                    <a:tab algn="l" pos="3441600"/>
                    <a:tab algn="l" pos="4302000"/>
                    <a:tab algn="l" pos="5162400"/>
                    <a:tab algn="l" pos="6022800"/>
                    <a:tab algn="l" pos="6883560"/>
                    <a:tab algn="l" pos="7743960"/>
                    <a:tab algn="l" pos="8604360"/>
                    <a:tab algn="l" pos="9464760"/>
                    <a:tab algn="l" pos="1032516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1" name=""/>
          <p:cNvSpPr/>
          <p:nvPr/>
        </p:nvSpPr>
        <p:spPr>
          <a:xfrm>
            <a:off x="108000" y="3336840"/>
            <a:ext cx="2124000" cy="22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600" rIns="84600" tIns="43920" bIns="43920" anchor="t">
            <a:spAutoFit/>
          </a:bodyPr>
          <a:p>
            <a:pPr>
              <a:tabLst>
                <a:tab algn="l" pos="0"/>
                <a:tab algn="l" pos="860400"/>
                <a:tab algn="l" pos="1720800"/>
                <a:tab algn="l" pos="2583000"/>
                <a:tab algn="l" pos="3443400"/>
                <a:tab algn="l" pos="4303800"/>
                <a:tab algn="l" pos="5164200"/>
                <a:tab algn="l" pos="6024600"/>
                <a:tab algn="l" pos="6886440"/>
                <a:tab algn="l" pos="7746840"/>
                <a:tab algn="l" pos="8607600"/>
                <a:tab algn="l" pos="9468000"/>
                <a:tab algn="l" pos="9894960"/>
                <a:tab algn="l" pos="10325160"/>
                <a:tab algn="l" pos="10755360"/>
              </a:tabLst>
            </a:pPr>
            <a:r>
              <a:rPr b="0" i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Musa </a:t>
            </a:r>
            <a:r>
              <a:rPr b="0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MA4_42M13 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(16 k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30320" y="3773520"/>
            <a:ext cx="1619280" cy="22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600" rIns="84600" tIns="43920" bIns="43920" anchor="t">
            <a:spAutoFit/>
          </a:bodyPr>
          <a:p>
            <a:pPr>
              <a:tabLst>
                <a:tab algn="l" pos="0"/>
                <a:tab algn="l" pos="860400"/>
                <a:tab algn="l" pos="1720800"/>
                <a:tab algn="l" pos="2583000"/>
                <a:tab algn="l" pos="3443400"/>
                <a:tab algn="l" pos="4303800"/>
                <a:tab algn="l" pos="5164200"/>
                <a:tab algn="l" pos="6024600"/>
                <a:tab algn="l" pos="6886440"/>
                <a:tab algn="l" pos="7746840"/>
                <a:tab algn="l" pos="8607600"/>
                <a:tab algn="l" pos="9468000"/>
                <a:tab algn="l" pos="9894960"/>
                <a:tab algn="l" pos="10325160"/>
                <a:tab algn="l" pos="1075536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Rice Chr2 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9kb)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0" y="2895480"/>
            <a:ext cx="55548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600" rIns="84600" tIns="43920" bIns="43920" anchor="t">
            <a:spAutoFit/>
          </a:bodyPr>
          <a:p>
            <a:pPr>
              <a:spcBef>
                <a:spcPts val="825"/>
              </a:spcBef>
              <a:tabLst>
                <a:tab algn="l" pos="0"/>
                <a:tab algn="l" pos="860400"/>
                <a:tab algn="l" pos="1720800"/>
                <a:tab algn="l" pos="2583000"/>
                <a:tab algn="l" pos="3443400"/>
                <a:tab algn="l" pos="4303800"/>
                <a:tab algn="l" pos="5164200"/>
                <a:tab algn="l" pos="6024600"/>
                <a:tab algn="l" pos="6886440"/>
                <a:tab algn="l" pos="7746840"/>
                <a:tab algn="l" pos="8607600"/>
                <a:tab algn="l" pos="9468000"/>
                <a:tab algn="l" pos="9894960"/>
                <a:tab algn="l" pos="10325160"/>
                <a:tab algn="l" pos="1075536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B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1473480" y="2917440"/>
            <a:ext cx="835920" cy="20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040" rIns="86040" tIns="43200" bIns="43200" anchor="t">
            <a:spAutoFit/>
          </a:bodyPr>
          <a:p>
            <a:pPr>
              <a:tabLst>
                <a:tab algn="l" pos="0"/>
                <a:tab algn="l" pos="860400"/>
                <a:tab algn="l" pos="1720800"/>
                <a:tab algn="l" pos="2581200"/>
                <a:tab algn="l" pos="3441600"/>
                <a:tab algn="l" pos="4302000"/>
                <a:tab algn="l" pos="5162400"/>
                <a:tab algn="l" pos="6022800"/>
                <a:tab algn="l" pos="6883560"/>
                <a:tab algn="l" pos="7743960"/>
                <a:tab algn="l" pos="8604360"/>
                <a:tab algn="l" pos="9464760"/>
                <a:tab algn="l" pos="1032516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A4_42M13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2135520" y="2920680"/>
            <a:ext cx="835920" cy="20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040" rIns="86040" tIns="43200" bIns="43200" anchor="t">
            <a:spAutoFit/>
          </a:bodyPr>
          <a:p>
            <a:pPr>
              <a:tabLst>
                <a:tab algn="l" pos="0"/>
                <a:tab algn="l" pos="860400"/>
                <a:tab algn="l" pos="1720800"/>
                <a:tab algn="l" pos="2581200"/>
                <a:tab algn="l" pos="3441600"/>
                <a:tab algn="l" pos="4302000"/>
                <a:tab algn="l" pos="5162400"/>
                <a:tab algn="l" pos="6022800"/>
                <a:tab algn="l" pos="6883560"/>
                <a:tab algn="l" pos="7743960"/>
                <a:tab algn="l" pos="8604360"/>
                <a:tab algn="l" pos="9464760"/>
                <a:tab algn="l" pos="1032516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A4_42M13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2895840" y="2920680"/>
            <a:ext cx="835920" cy="20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040" rIns="86040" tIns="43200" bIns="43200" anchor="t">
            <a:spAutoFit/>
          </a:bodyPr>
          <a:p>
            <a:pPr>
              <a:tabLst>
                <a:tab algn="l" pos="0"/>
                <a:tab algn="l" pos="860400"/>
                <a:tab algn="l" pos="1720800"/>
                <a:tab algn="l" pos="2581200"/>
                <a:tab algn="l" pos="3441600"/>
                <a:tab algn="l" pos="4302000"/>
                <a:tab algn="l" pos="5162400"/>
                <a:tab algn="l" pos="6022800"/>
                <a:tab algn="l" pos="6883560"/>
                <a:tab algn="l" pos="7743960"/>
                <a:tab algn="l" pos="8604360"/>
                <a:tab algn="l" pos="9464760"/>
                <a:tab algn="l" pos="1032516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A4_42M13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3591360" y="2917440"/>
            <a:ext cx="835920" cy="20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040" rIns="86040" tIns="43200" bIns="43200" anchor="t">
            <a:spAutoFit/>
          </a:bodyPr>
          <a:p>
            <a:pPr>
              <a:tabLst>
                <a:tab algn="l" pos="0"/>
                <a:tab algn="l" pos="860400"/>
                <a:tab algn="l" pos="1720800"/>
                <a:tab algn="l" pos="2581200"/>
                <a:tab algn="l" pos="3441600"/>
                <a:tab algn="l" pos="4302000"/>
                <a:tab algn="l" pos="5162400"/>
                <a:tab algn="l" pos="6022800"/>
                <a:tab algn="l" pos="6883560"/>
                <a:tab algn="l" pos="7743960"/>
                <a:tab algn="l" pos="8604360"/>
                <a:tab algn="l" pos="9464760"/>
                <a:tab algn="l" pos="1032516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A4_42M13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4217760" y="2837520"/>
            <a:ext cx="8920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040" rIns="86040" tIns="43200" bIns="43200" anchor="t">
            <a:spAutoFit/>
          </a:bodyPr>
          <a:p>
            <a:pPr>
              <a:spcBef>
                <a:spcPts val="825"/>
              </a:spcBef>
              <a:tabLst>
                <a:tab algn="l" pos="0"/>
                <a:tab algn="l" pos="860400"/>
                <a:tab algn="l" pos="1720800"/>
                <a:tab algn="l" pos="2581200"/>
                <a:tab algn="l" pos="3441600"/>
                <a:tab algn="l" pos="4302000"/>
                <a:tab algn="l" pos="5162400"/>
                <a:tab algn="l" pos="6022800"/>
                <a:tab algn="l" pos="6883560"/>
                <a:tab algn="l" pos="7743960"/>
                <a:tab algn="l" pos="8604360"/>
                <a:tab algn="l" pos="9464760"/>
                <a:tab algn="l" pos="1032516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A4_42M13.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60400"/>
                <a:tab algn="l" pos="1720800"/>
                <a:tab algn="l" pos="2581200"/>
                <a:tab algn="l" pos="3441600"/>
                <a:tab algn="l" pos="4302000"/>
                <a:tab algn="l" pos="5162400"/>
                <a:tab algn="l" pos="6022800"/>
                <a:tab algn="l" pos="6883560"/>
                <a:tab algn="l" pos="7743960"/>
                <a:tab algn="l" pos="8604360"/>
                <a:tab algn="l" pos="9464760"/>
                <a:tab algn="l" pos="1032516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"/>
          <p:cNvGrpSpPr/>
          <p:nvPr/>
        </p:nvGrpSpPr>
        <p:grpSpPr>
          <a:xfrm>
            <a:off x="1403280" y="4005360"/>
            <a:ext cx="2329920" cy="623160"/>
            <a:chOff x="1403280" y="4005360"/>
            <a:chExt cx="2329920" cy="623160"/>
          </a:xfrm>
        </p:grpSpPr>
        <p:sp>
          <p:nvSpPr>
            <p:cNvPr id="60" name=""/>
            <p:cNvSpPr/>
            <p:nvPr/>
          </p:nvSpPr>
          <p:spPr>
            <a:xfrm>
              <a:off x="2068200" y="4005360"/>
              <a:ext cx="75492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Os02g072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"/>
            <p:cNvGrpSpPr/>
            <p:nvPr/>
          </p:nvGrpSpPr>
          <p:grpSpPr>
            <a:xfrm>
              <a:off x="1403280" y="4227480"/>
              <a:ext cx="2329920" cy="401040"/>
              <a:chOff x="1403280" y="4227480"/>
              <a:chExt cx="2329920" cy="401040"/>
            </a:xfrm>
          </p:grpSpPr>
          <p:sp>
            <p:nvSpPr>
              <p:cNvPr id="62" name=""/>
              <p:cNvSpPr/>
              <p:nvPr/>
            </p:nvSpPr>
            <p:spPr>
              <a:xfrm>
                <a:off x="1403280" y="4227480"/>
                <a:ext cx="232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spcBef>
                    <a:spcPts val="587"/>
                  </a:spcBef>
                  <a:tabLst>
                    <a:tab algn="l" pos="0"/>
                    <a:tab algn="l" pos="860400"/>
                    <a:tab algn="l" pos="1720800"/>
                    <a:tab algn="l" pos="2583000"/>
                    <a:tab algn="l" pos="3443400"/>
                    <a:tab algn="l" pos="4303800"/>
                    <a:tab algn="l" pos="5164200"/>
                    <a:tab algn="l" pos="6024600"/>
                    <a:tab algn="l" pos="6886440"/>
                    <a:tab algn="l" pos="7746840"/>
                    <a:tab algn="l" pos="8607600"/>
                    <a:tab algn="l" pos="9468000"/>
                    <a:tab algn="l" pos="9894960"/>
                    <a:tab algn="l" pos="10325160"/>
                    <a:tab algn="l" pos="1075536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eptidylprolyl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230920" y="4298400"/>
                <a:ext cx="643680" cy="330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6040" rIns="86040" tIns="43200" bIns="43200" anchor="t">
                <a:spAutoFit/>
              </a:bodyPr>
              <a:p>
                <a:pPr algn="ctr">
                  <a:spcBef>
                    <a:spcPts val="587"/>
                  </a:spcBef>
                  <a:tabLst>
                    <a:tab algn="l" pos="0"/>
                    <a:tab algn="l" pos="860400"/>
                    <a:tab algn="l" pos="1720800"/>
                    <a:tab algn="l" pos="2581200"/>
                    <a:tab algn="l" pos="3441600"/>
                    <a:tab algn="l" pos="4302000"/>
                    <a:tab algn="l" pos="5162400"/>
                    <a:tab algn="l" pos="6022800"/>
                    <a:tab algn="l" pos="6883560"/>
                    <a:tab algn="l" pos="7743960"/>
                    <a:tab algn="l" pos="8604360"/>
                    <a:tab algn="l" pos="9464760"/>
                    <a:tab algn="l" pos="1032516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isomera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860400"/>
                    <a:tab algn="l" pos="1720800"/>
                    <a:tab algn="l" pos="2581200"/>
                    <a:tab algn="l" pos="3441600"/>
                    <a:tab algn="l" pos="4302000"/>
                    <a:tab algn="l" pos="5162400"/>
                    <a:tab algn="l" pos="6022800"/>
                    <a:tab algn="l" pos="6883560"/>
                    <a:tab algn="l" pos="7743960"/>
                    <a:tab algn="l" pos="8604360"/>
                    <a:tab algn="l" pos="9464760"/>
                    <a:tab algn="l" pos="1032516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4" name=""/>
          <p:cNvGrpSpPr/>
          <p:nvPr/>
        </p:nvGrpSpPr>
        <p:grpSpPr>
          <a:xfrm>
            <a:off x="1562040" y="3384720"/>
            <a:ext cx="3279600" cy="559800"/>
            <a:chOff x="1562040" y="3384720"/>
            <a:chExt cx="3279600" cy="559800"/>
          </a:xfrm>
        </p:grpSpPr>
        <p:sp>
          <p:nvSpPr>
            <p:cNvPr id="65" name=""/>
            <p:cNvSpPr/>
            <p:nvPr/>
          </p:nvSpPr>
          <p:spPr>
            <a:xfrm>
              <a:off x="3750480" y="3513600"/>
              <a:ext cx="1047960" cy="330840"/>
            </a:xfrm>
            <a:custGeom>
              <a:avLst/>
              <a:gdLst/>
              <a:ahLst/>
              <a:rect l="l" t="t" r="r" b="b"/>
              <a:pathLst>
                <a:path w="822" h="195">
                  <a:moveTo>
                    <a:pt x="0" y="171"/>
                  </a:moveTo>
                  <a:lnTo>
                    <a:pt x="576" y="0"/>
                  </a:lnTo>
                  <a:lnTo>
                    <a:pt x="822" y="0"/>
                  </a:lnTo>
                  <a:lnTo>
                    <a:pt x="168" y="195"/>
                  </a:lnTo>
                  <a:lnTo>
                    <a:pt x="0" y="171"/>
                  </a:lnTo>
                  <a:close/>
                </a:path>
              </a:pathLst>
            </a:cu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066120" y="3503520"/>
              <a:ext cx="1238040" cy="345960"/>
            </a:xfrm>
            <a:custGeom>
              <a:avLst/>
              <a:gdLst/>
              <a:ahLst/>
              <a:rect l="l" t="t" r="r" b="b"/>
              <a:pathLst>
                <a:path w="981" h="204">
                  <a:moveTo>
                    <a:pt x="0" y="177"/>
                  </a:moveTo>
                  <a:lnTo>
                    <a:pt x="528" y="0"/>
                  </a:lnTo>
                  <a:lnTo>
                    <a:pt x="981" y="6"/>
                  </a:lnTo>
                  <a:lnTo>
                    <a:pt x="423" y="180"/>
                  </a:lnTo>
                  <a:lnTo>
                    <a:pt x="30" y="204"/>
                  </a:lnTo>
                  <a:lnTo>
                    <a:pt x="0" y="177"/>
                  </a:lnTo>
                  <a:close/>
                </a:path>
              </a:pathLst>
            </a:cu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047400" y="3472560"/>
              <a:ext cx="586080" cy="335880"/>
            </a:xfrm>
            <a:custGeom>
              <a:avLst/>
              <a:gdLst/>
              <a:ahLst/>
              <a:rect l="l" t="t" r="r" b="b"/>
              <a:pathLst>
                <a:path w="465" h="198">
                  <a:moveTo>
                    <a:pt x="0" y="27"/>
                  </a:moveTo>
                  <a:lnTo>
                    <a:pt x="0" y="195"/>
                  </a:lnTo>
                  <a:lnTo>
                    <a:pt x="441" y="198"/>
                  </a:lnTo>
                  <a:lnTo>
                    <a:pt x="465" y="0"/>
                  </a:lnTo>
                  <a:lnTo>
                    <a:pt x="0" y="27"/>
                  </a:lnTo>
                  <a:close/>
                </a:path>
              </a:pathLst>
            </a:cu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061800" y="3543840"/>
              <a:ext cx="568080" cy="264600"/>
            </a:xfrm>
            <a:custGeom>
              <a:avLst/>
              <a:gdLst/>
              <a:ahLst/>
              <a:rect l="l" t="t" r="r" b="b"/>
              <a:pathLst>
                <a:path w="450" h="156">
                  <a:moveTo>
                    <a:pt x="0" y="153"/>
                  </a:moveTo>
                  <a:lnTo>
                    <a:pt x="450" y="0"/>
                  </a:lnTo>
                  <a:lnTo>
                    <a:pt x="426" y="156"/>
                  </a:lnTo>
                  <a:lnTo>
                    <a:pt x="0" y="153"/>
                  </a:lnTo>
                  <a:close/>
                </a:path>
              </a:pathLst>
            </a:custGeom>
            <a:solidFill>
              <a:srgbClr val="c2c2c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692360" y="3498120"/>
              <a:ext cx="1021680" cy="315360"/>
            </a:xfrm>
            <a:custGeom>
              <a:avLst/>
              <a:gdLst/>
              <a:ahLst/>
              <a:rect l="l" t="t" r="r" b="b"/>
              <a:pathLst>
                <a:path w="810" h="186">
                  <a:moveTo>
                    <a:pt x="0" y="9"/>
                  </a:moveTo>
                  <a:lnTo>
                    <a:pt x="513" y="180"/>
                  </a:lnTo>
                  <a:lnTo>
                    <a:pt x="810" y="186"/>
                  </a:lnTo>
                  <a:lnTo>
                    <a:pt x="210" y="0"/>
                  </a:lnTo>
                  <a:lnTo>
                    <a:pt x="0" y="9"/>
                  </a:lnTo>
                  <a:close/>
                </a:path>
              </a:pathLst>
            </a:custGeom>
            <a:solidFill>
              <a:srgbClr val="ddddd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228040" y="3880080"/>
              <a:ext cx="1848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0800000">
              <a:off x="2266560" y="3810600"/>
              <a:ext cx="453600" cy="133920"/>
            </a:xfrm>
            <a:custGeom>
              <a:avLst/>
              <a:gdLst>
                <a:gd name="textAreaLeft" fmla="*/ 0 w 453600"/>
                <a:gd name="textAreaRight" fmla="*/ 453960 w 453600"/>
                <a:gd name="textAreaTop" fmla="*/ 0 h 133920"/>
                <a:gd name="textAreaBottom" fmla="*/ 134280 h 133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8350" y="0"/>
                  </a:lnTo>
                  <a:lnTo>
                    <a:pt x="21600" y="10800"/>
                  </a:lnTo>
                  <a:lnTo>
                    <a:pt x="1835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dddddd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rot="10800000">
              <a:off x="3676320" y="3810600"/>
              <a:ext cx="365400" cy="133920"/>
            </a:xfrm>
            <a:custGeom>
              <a:avLst/>
              <a:gdLst>
                <a:gd name="textAreaLeft" fmla="*/ 0 w 365400"/>
                <a:gd name="textAreaRight" fmla="*/ 365760 w 365400"/>
                <a:gd name="textAreaTop" fmla="*/ 0 h 133920"/>
                <a:gd name="textAreaBottom" fmla="*/ 134280 h 133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7962" y="0"/>
                  </a:lnTo>
                  <a:lnTo>
                    <a:pt x="21600" y="10800"/>
                  </a:lnTo>
                  <a:lnTo>
                    <a:pt x="17962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049200" y="3810600"/>
              <a:ext cx="621360" cy="133920"/>
            </a:xfrm>
            <a:custGeom>
              <a:avLst/>
              <a:gdLst>
                <a:gd name="textAreaLeft" fmla="*/ 0 w 621360"/>
                <a:gd name="textAreaRight" fmla="*/ 621720 w 621360"/>
                <a:gd name="textAreaTop" fmla="*/ 0 h 133920"/>
                <a:gd name="textAreaBottom" fmla="*/ 134280 h 133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9098" y="0"/>
                  </a:lnTo>
                  <a:lnTo>
                    <a:pt x="21600" y="10800"/>
                  </a:lnTo>
                  <a:lnTo>
                    <a:pt x="19098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dddddd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562040" y="3452400"/>
              <a:ext cx="3279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rot="10800000">
              <a:off x="1612800" y="3385800"/>
              <a:ext cx="441360" cy="134280"/>
            </a:xfrm>
            <a:custGeom>
              <a:avLst/>
              <a:gdLst>
                <a:gd name="textAreaLeft" fmla="*/ 0 w 441360"/>
                <a:gd name="textAreaRight" fmla="*/ 441720 w 441360"/>
                <a:gd name="textAreaTop" fmla="*/ 0 h 134280"/>
                <a:gd name="textAreaBottom" fmla="*/ 134640 h 134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8082" y="0"/>
                  </a:lnTo>
                  <a:lnTo>
                    <a:pt x="21600" y="10800"/>
                  </a:lnTo>
                  <a:lnTo>
                    <a:pt x="18082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dddddd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415960" y="3384720"/>
              <a:ext cx="445680" cy="133920"/>
            </a:xfrm>
            <a:custGeom>
              <a:avLst/>
              <a:gdLst>
                <a:gd name="textAreaLeft" fmla="*/ 0 w 445680"/>
                <a:gd name="textAreaRight" fmla="*/ 446040 w 445680"/>
                <a:gd name="textAreaTop" fmla="*/ 0 h 133920"/>
                <a:gd name="textAreaBottom" fmla="*/ 134280 h 133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8418" y="0"/>
                  </a:lnTo>
                  <a:lnTo>
                    <a:pt x="21600" y="10800"/>
                  </a:lnTo>
                  <a:lnTo>
                    <a:pt x="18418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045240" y="3384720"/>
              <a:ext cx="672120" cy="133920"/>
            </a:xfrm>
            <a:custGeom>
              <a:avLst/>
              <a:gdLst>
                <a:gd name="textAreaLeft" fmla="*/ 0 w 672120"/>
                <a:gd name="textAreaRight" fmla="*/ 672480 w 672120"/>
                <a:gd name="textAreaTop" fmla="*/ 0 h 133920"/>
                <a:gd name="textAreaBottom" fmla="*/ 134280 h 133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9123" y="0"/>
                  </a:lnTo>
                  <a:lnTo>
                    <a:pt x="21600" y="10800"/>
                  </a:lnTo>
                  <a:lnTo>
                    <a:pt x="19123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dddddd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717360" y="3384720"/>
              <a:ext cx="651960" cy="133920"/>
            </a:xfrm>
            <a:custGeom>
              <a:avLst/>
              <a:gdLst>
                <a:gd name="textAreaLeft" fmla="*/ 0 w 651960"/>
                <a:gd name="textAreaRight" fmla="*/ 652320 w 651960"/>
                <a:gd name="textAreaTop" fmla="*/ 0 h 133920"/>
                <a:gd name="textAreaBottom" fmla="*/ 134280 h 133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9219" y="0"/>
                  </a:lnTo>
                  <a:lnTo>
                    <a:pt x="21600" y="10800"/>
                  </a:lnTo>
                  <a:lnTo>
                    <a:pt x="19219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dddddd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688400" y="3518640"/>
              <a:ext cx="647640" cy="28512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048400" y="3529080"/>
              <a:ext cx="665640" cy="28476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047400" y="3508560"/>
              <a:ext cx="3960" cy="30528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H="1">
              <a:off x="3603240" y="3513600"/>
              <a:ext cx="34560" cy="29520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3051360" y="3508560"/>
              <a:ext cx="665640" cy="30024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H="1">
              <a:off x="3588840" y="3523680"/>
              <a:ext cx="702720" cy="29556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H="1">
              <a:off x="3731400" y="3523680"/>
              <a:ext cx="725400" cy="28512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H="1">
              <a:off x="4029840" y="3518640"/>
              <a:ext cx="780120" cy="29520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0800000">
              <a:off x="4393800" y="3385800"/>
              <a:ext cx="416520" cy="134280"/>
            </a:xfrm>
            <a:custGeom>
              <a:avLst/>
              <a:gdLst>
                <a:gd name="textAreaLeft" fmla="*/ 0 w 416520"/>
                <a:gd name="textAreaRight" fmla="*/ 416880 w 416520"/>
                <a:gd name="textAreaTop" fmla="*/ 0 h 134280"/>
                <a:gd name="textAreaBottom" fmla="*/ 134640 h 134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8141" y="0"/>
                  </a:lnTo>
                  <a:lnTo>
                    <a:pt x="21600" y="10800"/>
                  </a:lnTo>
                  <a:lnTo>
                    <a:pt x="18141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8" name=""/>
          <p:cNvSpPr/>
          <p:nvPr/>
        </p:nvSpPr>
        <p:spPr>
          <a:xfrm>
            <a:off x="0" y="15840"/>
            <a:ext cx="55548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600" rIns="84600" tIns="43920" bIns="43920" anchor="t">
            <a:spAutoFit/>
          </a:bodyPr>
          <a:p>
            <a:pPr>
              <a:spcBef>
                <a:spcPts val="825"/>
              </a:spcBef>
              <a:tabLst>
                <a:tab algn="l" pos="0"/>
                <a:tab algn="l" pos="860400"/>
                <a:tab algn="l" pos="1720800"/>
                <a:tab algn="l" pos="2583000"/>
                <a:tab algn="l" pos="3443400"/>
                <a:tab algn="l" pos="4303800"/>
                <a:tab algn="l" pos="5164200"/>
                <a:tab algn="l" pos="6024600"/>
                <a:tab algn="l" pos="6886440"/>
                <a:tab algn="l" pos="7746840"/>
                <a:tab algn="l" pos="8607600"/>
                <a:tab algn="l" pos="9468000"/>
                <a:tab algn="l" pos="9894960"/>
                <a:tab algn="l" pos="10325160"/>
                <a:tab algn="l" pos="1075536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731960" y="0"/>
            <a:ext cx="3776760" cy="22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600" rIns="84600" tIns="43920" bIns="43920" anchor="t">
            <a:spAutoFit/>
          </a:bodyPr>
          <a:p>
            <a:pPr>
              <a:spcBef>
                <a:spcPts val="825"/>
              </a:spcBef>
              <a:tabLst>
                <a:tab algn="l" pos="0"/>
                <a:tab algn="l" pos="860400"/>
                <a:tab algn="l" pos="1720800"/>
                <a:tab algn="l" pos="2583000"/>
                <a:tab algn="l" pos="3443400"/>
                <a:tab algn="l" pos="4303800"/>
                <a:tab algn="l" pos="5164200"/>
                <a:tab algn="l" pos="6024600"/>
                <a:tab algn="l" pos="6886440"/>
                <a:tab algn="l" pos="7746840"/>
                <a:tab algn="l" pos="8607600"/>
                <a:tab algn="l" pos="9468000"/>
                <a:tab algn="l" pos="9894960"/>
                <a:tab algn="l" pos="10325160"/>
                <a:tab algn="l" pos="10755360"/>
              </a:tabLst>
            </a:pPr>
            <a:r>
              <a:rPr b="0" i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Musa</a:t>
            </a:r>
            <a:r>
              <a:rPr b="0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 MA4_42M13 BAC clone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108000" y="230040"/>
            <a:ext cx="4320720" cy="2352600"/>
            <a:chOff x="108000" y="230040"/>
            <a:chExt cx="4320720" cy="2352600"/>
          </a:xfrm>
        </p:grpSpPr>
        <p:sp>
          <p:nvSpPr>
            <p:cNvPr id="91" name=""/>
            <p:cNvSpPr/>
            <p:nvPr/>
          </p:nvSpPr>
          <p:spPr>
            <a:xfrm rot="16200000">
              <a:off x="-441000" y="1356840"/>
              <a:ext cx="132408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600" rIns="84600" tIns="43920" bIns="43920" anchor="t">
              <a:spAutoFit/>
            </a:bodyPr>
            <a:p>
              <a:pPr algn="ctr">
                <a:spcBef>
                  <a:spcPts val="825"/>
                </a:spcBef>
                <a:tabLst>
                  <a:tab algn="l" pos="0"/>
                  <a:tab algn="l" pos="860400"/>
                  <a:tab algn="l" pos="1720800"/>
                  <a:tab algn="l" pos="2583000"/>
                  <a:tab algn="l" pos="3443400"/>
                  <a:tab algn="l" pos="4303800"/>
                  <a:tab algn="l" pos="5164200"/>
                  <a:tab algn="l" pos="6024600"/>
                  <a:tab algn="l" pos="6886440"/>
                  <a:tab algn="l" pos="7746840"/>
                  <a:tab algn="l" pos="8607600"/>
                  <a:tab algn="l" pos="9468000"/>
                  <a:tab algn="l" pos="9894960"/>
                  <a:tab algn="l" pos="10325160"/>
                  <a:tab algn="l" pos="1075536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ce Chr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2" name="" descr=""/>
            <p:cNvPicPr/>
            <p:nvPr/>
          </p:nvPicPr>
          <p:blipFill>
            <a:blip r:embed="rId1"/>
            <a:stretch/>
          </p:blipFill>
          <p:spPr>
            <a:xfrm>
              <a:off x="642600" y="348120"/>
              <a:ext cx="3786120" cy="223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"/>
            <p:cNvSpPr/>
            <p:nvPr/>
          </p:nvSpPr>
          <p:spPr>
            <a:xfrm>
              <a:off x="1001160" y="585000"/>
              <a:ext cx="550080" cy="486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432160" y="1279080"/>
              <a:ext cx="1551240" cy="6058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982320" y="1905840"/>
              <a:ext cx="429480" cy="4251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813960" y="351360"/>
              <a:ext cx="3573000" cy="70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400" bIns="23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653040" y="425160"/>
              <a:ext cx="227160" cy="2029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60720" y="447480"/>
              <a:ext cx="45468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4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67200" y="815400"/>
              <a:ext cx="45468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6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60720" y="1176840"/>
              <a:ext cx="45468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8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67200" y="1540080"/>
              <a:ext cx="45468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67200" y="1893240"/>
              <a:ext cx="45468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2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67200" y="2262960"/>
              <a:ext cx="45468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4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773640" y="230040"/>
              <a:ext cx="25812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761120" y="239760"/>
              <a:ext cx="42732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00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803680" y="237960"/>
              <a:ext cx="48384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00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857040" y="237960"/>
              <a:ext cx="483840" cy="2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6040" rIns="86040" tIns="43200" bIns="43200" anchor="t">
              <a:spAutoFit/>
            </a:bodyPr>
            <a:p>
              <a:pPr>
                <a:tabLst>
                  <a:tab algn="l" pos="0"/>
                  <a:tab algn="l" pos="860400"/>
                  <a:tab algn="l" pos="1720800"/>
                  <a:tab algn="l" pos="2581200"/>
                  <a:tab algn="l" pos="3441600"/>
                  <a:tab algn="l" pos="4302000"/>
                  <a:tab algn="l" pos="5162400"/>
                  <a:tab algn="l" pos="6022800"/>
                  <a:tab algn="l" pos="6883560"/>
                  <a:tab algn="l" pos="7743960"/>
                  <a:tab algn="l" pos="8604360"/>
                  <a:tab algn="l" pos="9464760"/>
                  <a:tab algn="l" pos="103251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5000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424400" y="463320"/>
              <a:ext cx="0" cy="208080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18T22:04:55Z</dcterms:created>
  <dc:creator>CNRS</dc:creator>
  <dc:description/>
  <dc:language>en-US</dc:language>
  <cp:lastModifiedBy>CNRS</cp:lastModifiedBy>
  <dcterms:modified xsi:type="dcterms:W3CDTF">2008-01-18T22:06:27Z</dcterms:modified>
  <cp:revision>1</cp:revision>
  <dc:subject/>
  <dc:title>Diapositive 1</dc:title>
</cp:coreProperties>
</file>